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FC832-9049-490F-BFFA-931E32AC82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27D06-1756-4454-8F50-030656BD25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FFAE3-9495-40FF-B142-5743489B3A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B315C-0DBC-45B1-B131-855502842D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19427-7626-45D5-BA7D-1A66DF6AF3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3E5FF-9367-4A03-9D87-84DF1D1F68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8C53E-22C7-4B0A-B5FC-B4780BB72C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C3BB0-E9BE-4EA4-BE03-478D087F8C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A63A6-621C-4687-89DB-AA476FA188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A9921-A5DB-4ADF-BF73-302064D1FA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E91434-65BD-451C-8182-B445A8E18E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B94D2-15FD-4FEE-8A8A-CF061DB390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2B6E9B-2C01-404E-A3E8-26896995EAC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"/>
          <p:cNvSpPr/>
          <p:nvPr/>
        </p:nvSpPr>
        <p:spPr>
          <a:xfrm>
            <a:off x="4356000" y="981000"/>
            <a:ext cx="4392720" cy="179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9. Overlapping PCR assays of the plasmids encoding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in four isolates using primers designed to amplify the toxin region.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Shown are results using DNA from strains (PB-1, 3441, TGII002 and TGII003), which carries the variant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gene and variant iota genes, and from NCTC8084 type E strain carrying the silent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gene and iota gen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6" descr=""/>
          <p:cNvPicPr/>
          <p:nvPr/>
        </p:nvPicPr>
        <p:blipFill>
          <a:blip r:embed="rId1"/>
          <a:stretch/>
        </p:blipFill>
        <p:spPr>
          <a:xfrm>
            <a:off x="971640" y="687240"/>
            <a:ext cx="3114720" cy="5483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5:50Z</dcterms:modified>
  <cp:revision>9</cp:revision>
  <dc:subject/>
  <dc:title>スライド 1</dc:title>
</cp:coreProperties>
</file>